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8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734" autoAdjust="0"/>
    <p:restoredTop sz="94660"/>
  </p:normalViewPr>
  <p:slideViewPr>
    <p:cSldViewPr snapToGrid="0">
      <p:cViewPr>
        <p:scale>
          <a:sx n="66" d="100"/>
          <a:sy n="66" d="100"/>
        </p:scale>
        <p:origin x="939" y="2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  <a:endParaRPr lang="en-US"/>
          </a:p>
          <a:p>
            <a:pPr lvl="1"/>
            <a:r>
              <a:rPr lang="en-US"/>
              <a:t>Second level</a:t>
            </a:r>
            <a:endParaRPr lang="en-US"/>
          </a:p>
          <a:p>
            <a:pPr lvl="2"/>
            <a:r>
              <a:rPr lang="en-US"/>
              <a:t>Third level</a:t>
            </a:r>
            <a:endParaRPr lang="en-US"/>
          </a:p>
          <a:p>
            <a:pPr lvl="3"/>
            <a:r>
              <a:rPr lang="en-US"/>
              <a:t>Fourth level</a:t>
            </a:r>
            <a:endParaRPr lang="en-US"/>
          </a:p>
          <a:p>
            <a:pPr lvl="4"/>
            <a:r>
              <a:rPr lang="en-US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8AB607-B021-4ADB-A735-1122EAD60095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10C511-16B3-4C64-A057-AB0B13E74B96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90252" y="511713"/>
            <a:ext cx="6094926" cy="354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16205" algn="just" defTabSz="114300">
              <a:lnSpc>
                <a:spcPct val="95000"/>
              </a:lnSpc>
            </a:pPr>
            <a:r>
              <a:rPr lang="en-US" sz="1800" b="1" dirty="0">
                <a:solidFill>
                  <a:srgbClr val="000000"/>
                </a:solidFill>
                <a:effectLst/>
                <a:highlight>
                  <a:srgbClr val="FFFF00"/>
                </a:highlight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1</a:t>
            </a:r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ers used for ORF cloning and qPCR.</a:t>
            </a:r>
            <a:endParaRPr lang="en-US" sz="2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/>
        </p:nvGraphicFramePr>
        <p:xfrm>
          <a:off x="1044686" y="968208"/>
          <a:ext cx="9271291" cy="491934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83326"/>
                <a:gridCol w="4814289"/>
                <a:gridCol w="2573676"/>
              </a:tblGrid>
              <a:tr h="382270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400" b="0" dirty="0">
                          <a:ln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Primer name</a:t>
                      </a:r>
                      <a:endParaRPr lang="en-US" sz="1400" b="0" dirty="0">
                        <a:ln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50000"/>
                        </a:lnSpc>
                      </a:pPr>
                      <a:r>
                        <a:rPr lang="en-US" sz="1400" b="0" kern="1200" dirty="0">
                          <a:ln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Primer sequence (5′ -3′)</a:t>
                      </a:r>
                      <a:endParaRPr lang="en-US" sz="1400" b="0" kern="1200" dirty="0">
                        <a:ln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50000"/>
                        </a:lnSpc>
                      </a:pPr>
                      <a:r>
                        <a:rPr lang="en-US" sz="1400" b="0" kern="1200" dirty="0">
                          <a:ln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Purpose</a:t>
                      </a:r>
                      <a:endParaRPr lang="en-US" sz="1400" b="0" kern="1200" dirty="0">
                        <a:ln>
                          <a:solidFill>
                            <a:schemeClr val="tx1"/>
                          </a:solidFill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RIPK5-F1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CCGCTACGCAGACTAAACATGTTA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4">
                  <a:txBody>
                    <a:bodyPr/>
                    <a:lstStyle/>
                    <a:p>
                      <a:pPr marL="75565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-RIPK5 ORF PC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26244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RIPK5-F2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GCTAATTTATACTTACAGCCTA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RIPK5-R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TTGCACATACACTGGAGATACACTA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RIPK5-R2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CTCTATCACATTGCATACTTCCTA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RIPK7-F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AGTTTTGTGTGTCCATCCATA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rowSpan="4">
                  <a:txBody>
                    <a:bodyPr/>
                    <a:lstStyle/>
                    <a:p>
                      <a:pPr marL="75565" algn="just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-RIPK7 ORF PC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RIPK7-F2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TGGTACTTACCTTCCAGTGTGAA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RIPK7-R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CCACCTCTAGATCATCTTCAGT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RIPK7-R2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CATGCAACAGAAACCATGCAA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MLKL-F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GTTACCACATAGACAAGGCT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marL="75565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-MLKL ORF PC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MLKL-R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CCGAACACATTGACGAATTG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QHlRIPK5-F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GAGGCAGGTCCAGATCAGT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marL="75565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-RIPK5 qPC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QHlRIPK5-R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TGTGCATTGTTTGACGGC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QHlRIPK7-F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GGCGGTCGTCTCTAAGTCT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marL="75565" algn="just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-RIPK7 qPCR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QHlRIPK7-R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GGGAAGGGAACTCATCACG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QHlMLKL-F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CTGCTGCAAGGGCATTCTA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marL="75565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-MLKL qPC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QHlMLKL-R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CGTAAGATCGACGACTGGC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vMerge="1">
                  <a:tcPr/>
                </a:tc>
              </a:tr>
              <a:tr h="239975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QHlEF-F1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CATGCAAGTTCGCTGCCATT</a:t>
                      </a:r>
                      <a:endParaRPr lang="en-US" sz="110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marL="75565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l-EF qPCR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7718">
                <a:tc>
                  <a:txBody>
                    <a:bodyPr/>
                    <a:lstStyle/>
                    <a:p>
                      <a:pPr marL="80645" algn="l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QHlEF-R1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73660" algn="just">
                        <a:lnSpc>
                          <a:spcPct val="150000"/>
                        </a:lnSpc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TGGCTTGGTTGGCTTCAGAT</a:t>
                      </a:r>
                      <a:endParaRPr lang="en-US" sz="11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cPr/>
                </a:tc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/>
        </p:nvGraphicFramePr>
        <p:xfrm>
          <a:off x="2032000" y="719666"/>
          <a:ext cx="8127999" cy="3708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709333"/>
                <a:gridCol w="2709333"/>
                <a:gridCol w="2709333"/>
              </a:tblGrid>
              <a:tr h="370840"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noFill/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68659" y="143694"/>
            <a:ext cx="11209448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able S2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Information of species and peptide sequences of RIPK gene family and MLKL used for analysis.</a:t>
            </a:r>
            <a:endParaRPr lang="en-US" dirty="0"/>
          </a:p>
        </p:txBody>
      </p:sp>
      <p:graphicFrame>
        <p:nvGraphicFramePr>
          <p:cNvPr id="9" name="Table 8"/>
          <p:cNvGraphicFramePr>
            <a:graphicFrameLocks noGrp="1"/>
          </p:cNvGraphicFramePr>
          <p:nvPr/>
        </p:nvGraphicFramePr>
        <p:xfrm>
          <a:off x="368658" y="607543"/>
          <a:ext cx="10912498" cy="600208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830424"/>
                <a:gridCol w="2146114"/>
                <a:gridCol w="87224"/>
                <a:gridCol w="3536345"/>
                <a:gridCol w="2312391"/>
              </a:tblGrid>
              <a:tr h="275519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Specie name (brief gene name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enBank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ccession number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Specie name ( brief gene name)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enBank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</a:endParaRPr>
                    </a:p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ccession number</a:t>
                      </a:r>
                      <a:endParaRPr lang="en-US" sz="14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IPK1</a:t>
                      </a: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30912" marR="30912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m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pien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s-RIPK5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P00000356130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Acanthaster</a:t>
                      </a: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planci</a:t>
                      </a: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p-RIPK1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P_022106097.1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g-RIPK5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GALP00000048862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Branchiostom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lanceolatum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Bl-RIPK1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BL06246 evm0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RIPK6</a:t>
                      </a:r>
                      <a:endParaRPr lang="en-US" sz="1200" b="1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Branchiostom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lanceolatum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Bl-RIPK1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BL06247 cuf4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m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pien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s-RIPK6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P00000373600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an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er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r-RIPK1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DARG00000006677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g-RIPK6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GALP0000001155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en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ropic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t-RIPK1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XETT00000024915.2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en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ropic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t-RIPK6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XETT00000034737.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m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pien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s-RIPK1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P0000036977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an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er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r-RIPK6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DARG00000007398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g-RIPK1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GALP00000036418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ccogloss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kowalevskii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k-RIPK6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P_002736404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IPK2</a:t>
                      </a: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30912" marR="30912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anthaster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planci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p-RIPK6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P_022111022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g-RIPK2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GALP00000046771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IPK7</a:t>
                      </a: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en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ropic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t-RIPK2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XETT00000064959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anthaster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planci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p-RIPK7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P_022097750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m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pien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s-RIPK2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P0000022075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lothuri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leucospilot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l-RIPK7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OLleu0540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an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er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r-RIPK2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DARG00000104290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an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er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r-RIPK7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DARG00000006169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23478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ion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intestin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i-RIPK2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CINT00000007374.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en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ropic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t-RIPK7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XETT00000033900.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IPK3</a:t>
                      </a: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30912" marR="30912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g-RIPK7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GALP00000052474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en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ropic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t-RIPK3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XETT00000003560.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m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pien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s-RIPK7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P00000298910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an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er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r-RIPK3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DARG0000010564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MLKL</a:t>
                      </a: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m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pien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s-RIPK3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P00000216274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postich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japonic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j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-MLK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PIK49055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IPK4</a:t>
                      </a: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30912" marR="30912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postich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japonic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j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-MLK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PIK47949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an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er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r-RIPK4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DARG0000004321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postich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japonic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j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-MLK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PIK49054.1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en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ropic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r-RIPK4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XETT00000000115.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lothuri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leucospilot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l-MLK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OLleu05122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m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pien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s-RIPK4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P0000033016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anthaster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planci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p-MLK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P_022087427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Gg-RIPK4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GALP0000004629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Branchiostom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lanceolatum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Bl-MLK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BL06251 evm0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IPK5</a:t>
                      </a:r>
                      <a:endParaRPr lang="en-US" sz="1200" b="1" kern="120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+mn-cs"/>
                      </a:endParaRPr>
                    </a:p>
                  </a:txBody>
                  <a:tcPr marL="30912" marR="30912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Pseudomona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eruginos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PFL (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Pf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-MLK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pf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20150316 1g939.t1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lothuri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leucospilot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l-RIPK5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HOLleu04795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ccogloss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kowalevskii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k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-MLK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P_006822660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221010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postich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japonic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j-RIPK5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PIK55269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ccogloss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kowalevskii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k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-MLKL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P_002737420.1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Acanthaster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planci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Ap-RIPK5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P_022110061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Ciona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intestin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Ci-MLKL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CINT00000011085.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ccogloss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kowalevskii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Sk-RIPK5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P_006816396.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Xen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tropic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</a:t>
                      </a:r>
                      <a:r>
                        <a:rPr lang="en-US" sz="1200" b="0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t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-MLKL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XETT00000016703.2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233712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Dan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reri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Dr-RIPK5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DARG0000000085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Homo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kern="120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+mn-cs"/>
                        </a:rPr>
                        <a:t>sapien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Hs-MLKL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P00000308351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noFill/>
                  </a:tcPr>
                </a:tc>
              </a:tr>
              <a:tr h="137387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Xenop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tropicali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Xt-RIPK5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XETT00000001971.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1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</a:t>
                      </a:r>
                      <a:r>
                        <a:rPr lang="en-US" sz="1200" b="0" i="1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gallus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 (Gg-MLKL)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</a:rPr>
                        <a:t>ENSGALP00000004360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30912" marR="30912" marT="0" marB="0" anchor="ctr"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mU5ZjMyODc1MmI5MzZjZGYwZmFmMDkwOWIxOTY5YmMifQ=="/>
</p:tagLst>
</file>

<file path=ppt/theme/theme1.xml><?xml version="1.0" encoding="utf-8"?>
<a:theme xmlns:a="http://schemas.openxmlformats.org/drawingml/2006/main" name="Office Theme">
  <a:themeElements>
    <a:clrScheme name="Aspect">
      <a:dk1>
        <a:sysClr val="windowText" lastClr="000000"/>
      </a:dk1>
      <a:lt1>
        <a:sysClr val="window" lastClr="FFFFFF"/>
      </a:lt1>
      <a:dk2>
        <a:srgbClr val="323232"/>
      </a:dk2>
      <a:lt2>
        <a:srgbClr val="E3DED1"/>
      </a:lt2>
      <a:accent1>
        <a:srgbClr val="F07F09"/>
      </a:accent1>
      <a:accent2>
        <a:srgbClr val="9F2936"/>
      </a:accent2>
      <a:accent3>
        <a:srgbClr val="1B587C"/>
      </a:accent3>
      <a:accent4>
        <a:srgbClr val="4E8542"/>
      </a:accent4>
      <a:accent5>
        <a:srgbClr val="604878"/>
      </a:accent5>
      <a:accent6>
        <a:srgbClr val="C19859"/>
      </a:accent6>
      <a:hlink>
        <a:srgbClr val="6B9F25"/>
      </a:hlink>
      <a:folHlink>
        <a:srgbClr val="B26B0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37</Words>
  <Application>WPS 演示</Application>
  <PresentationFormat>Widescreen</PresentationFormat>
  <Paragraphs>368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3" baseType="lpstr">
      <vt:lpstr>Arial</vt:lpstr>
      <vt:lpstr>宋体</vt:lpstr>
      <vt:lpstr>Wingdings</vt:lpstr>
      <vt:lpstr>Palatino Linotype</vt:lpstr>
      <vt:lpstr>Times New Roman</vt:lpstr>
      <vt:lpstr>微软雅黑</vt:lpstr>
      <vt:lpstr>Arial Unicode MS</vt:lpstr>
      <vt:lpstr>Calibri Light</vt:lpstr>
      <vt:lpstr>Calibri</vt:lpstr>
      <vt:lpstr>等线</vt:lpstr>
      <vt:lpstr>Office Theme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ve RAO</dc:creator>
  <cp:lastModifiedBy>cr</cp:lastModifiedBy>
  <cp:revision>9</cp:revision>
  <dcterms:created xsi:type="dcterms:W3CDTF">2024-09-29T03:02:00Z</dcterms:created>
  <dcterms:modified xsi:type="dcterms:W3CDTF">2024-09-29T12:36:2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17CB08F2B674D6FBB8D54534B30E244_12</vt:lpwstr>
  </property>
  <property fmtid="{D5CDD505-2E9C-101B-9397-08002B2CF9AE}" pid="3" name="KSOProductBuildVer">
    <vt:lpwstr>2052-12.1.0.17827</vt:lpwstr>
  </property>
</Properties>
</file>